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4"/>
  </p:sldMasterIdLst>
  <p:sldIdLst>
    <p:sldId id="257" r:id="rId5"/>
  </p:sldIdLst>
  <p:sldSz cx="8999538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5379784-DCB2-BFEA-7E56-DA9FF7BF3663}" name="Cancer Communications" initials="CC" userId="Cancer Communications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0F8FA"/>
    <a:srgbClr val="FFF8E7"/>
    <a:srgbClr val="538F8F"/>
    <a:srgbClr val="575D5E"/>
    <a:srgbClr val="303435"/>
    <a:srgbClr val="FFF1D0"/>
    <a:srgbClr val="E2F2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88027E0-45A0-41DC-8CC1-0962D231DFB2}" v="2" dt="2024-01-09T00:36:02.36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>
      <p:cViewPr>
        <p:scale>
          <a:sx n="100" d="100"/>
          <a:sy n="100" d="100"/>
        </p:scale>
        <p:origin x="368" y="-15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userId="23124619869_tp_box_2" providerId="OAuth2" clId="{188027E0-45A0-41DC-8CC1-0962D231DFB2}"/>
    <pc:docChg chg="modSld">
      <pc:chgData name="" userId="23124619869_tp_box_2" providerId="OAuth2" clId="{188027E0-45A0-41DC-8CC1-0962D231DFB2}" dt="2024-01-09T00:37:16.830" v="64" actId="20577"/>
      <pc:docMkLst>
        <pc:docMk/>
      </pc:docMkLst>
      <pc:sldChg chg="modSp mod">
        <pc:chgData name="" userId="23124619869_tp_box_2" providerId="OAuth2" clId="{188027E0-45A0-41DC-8CC1-0962D231DFB2}" dt="2024-01-09T00:37:16.830" v="64" actId="20577"/>
        <pc:sldMkLst>
          <pc:docMk/>
          <pc:sldMk cId="1668848167" sldId="257"/>
        </pc:sldMkLst>
        <pc:spChg chg="mod">
          <ac:chgData name="" userId="23124619869_tp_box_2" providerId="OAuth2" clId="{188027E0-45A0-41DC-8CC1-0962D231DFB2}" dt="2024-01-09T00:37:16.830" v="64" actId="20577"/>
          <ac:spMkLst>
            <pc:docMk/>
            <pc:sldMk cId="1668848167" sldId="257"/>
            <ac:spMk id="9" creationId="{CF855FF8-F4F4-BCCF-57A0-87ECAEFDCD09}"/>
          </ac:spMkLst>
        </pc:spChg>
        <pc:spChg chg="mod">
          <ac:chgData name="" userId="23124619869_tp_box_2" providerId="OAuth2" clId="{188027E0-45A0-41DC-8CC1-0962D231DFB2}" dt="2024-01-09T00:35:16.125" v="5" actId="20577"/>
          <ac:spMkLst>
            <pc:docMk/>
            <pc:sldMk cId="1668848167" sldId="257"/>
            <ac:spMk id="10" creationId="{17DC69C5-8D61-2AAF-D6CB-614D8BE8E550}"/>
          </ac:spMkLst>
        </pc:spChg>
        <pc:spChg chg="mod">
          <ac:chgData name="" userId="23124619869_tp_box_2" providerId="OAuth2" clId="{188027E0-45A0-41DC-8CC1-0962D231DFB2}" dt="2024-01-09T00:35:42.252" v="35" actId="20577"/>
          <ac:spMkLst>
            <pc:docMk/>
            <pc:sldMk cId="1668848167" sldId="257"/>
            <ac:spMk id="20" creationId="{45BAA248-F73B-DF54-2CD6-C6E669DE16AF}"/>
          </ac:spMkLst>
        </pc:spChg>
        <pc:spChg chg="mod">
          <ac:chgData name="" userId="23124619869_tp_box_2" providerId="OAuth2" clId="{188027E0-45A0-41DC-8CC1-0962D231DFB2}" dt="2024-01-09T00:35:03.368" v="0" actId="20577"/>
          <ac:spMkLst>
            <pc:docMk/>
            <pc:sldMk cId="1668848167" sldId="257"/>
            <ac:spMk id="27" creationId="{FBC26D85-D9CA-0C6C-482D-50D878A09891}"/>
          </ac:spMkLst>
        </pc:spChg>
        <pc:spChg chg="mod">
          <ac:chgData name="" userId="23124619869_tp_box_2" providerId="OAuth2" clId="{188027E0-45A0-41DC-8CC1-0962D231DFB2}" dt="2024-01-09T00:36:11.186" v="37" actId="1076"/>
          <ac:spMkLst>
            <pc:docMk/>
            <pc:sldMk cId="1668848167" sldId="257"/>
            <ac:spMk id="55" creationId="{FEAC3F51-2C97-DCA0-1290-BB75FE3C52BC}"/>
          </ac:spMkLst>
        </pc:spChg>
        <pc:spChg chg="mod">
          <ac:chgData name="" userId="23124619869_tp_box_2" providerId="OAuth2" clId="{188027E0-45A0-41DC-8CC1-0962D231DFB2}" dt="2024-01-09T00:36:25.587" v="58" actId="20577"/>
          <ac:spMkLst>
            <pc:docMk/>
            <pc:sldMk cId="1668848167" sldId="257"/>
            <ac:spMk id="60" creationId="{B3AF24C3-C771-768B-6A0F-2A5380AD6E4D}"/>
          </ac:spMkLst>
        </pc:spChg>
        <pc:spChg chg="mod">
          <ac:chgData name="" userId="23124619869_tp_box_2" providerId="OAuth2" clId="{188027E0-45A0-41DC-8CC1-0962D231DFB2}" dt="2024-01-09T00:36:29.517" v="63" actId="20577"/>
          <ac:spMkLst>
            <pc:docMk/>
            <pc:sldMk cId="1668848167" sldId="257"/>
            <ac:spMk id="61" creationId="{06A61422-295E-9319-64A8-1AA65554E99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472842"/>
            <a:ext cx="7649607" cy="3133172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4726842"/>
            <a:ext cx="6749654" cy="2172804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AF5CE-87E6-4BB0-8F04-D2AD62744F46}" type="datetimeFigureOut">
              <a:rPr lang="en-GB" smtClean="0"/>
              <a:t>08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70C4E-BEFB-4645-A30F-FA77502E9D68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349327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AF5CE-87E6-4BB0-8F04-D2AD62744F46}" type="datetimeFigureOut">
              <a:rPr lang="en-GB" smtClean="0"/>
              <a:t>08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70C4E-BEFB-4645-A30F-FA77502E9D68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68261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479142"/>
            <a:ext cx="1940525" cy="762669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479142"/>
            <a:ext cx="5709082" cy="762669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AF5CE-87E6-4BB0-8F04-D2AD62744F46}" type="datetimeFigureOut">
              <a:rPr lang="en-GB" smtClean="0"/>
              <a:t>08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70C4E-BEFB-4645-A30F-FA77502E9D68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18062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AF5CE-87E6-4BB0-8F04-D2AD62744F46}" type="datetimeFigureOut">
              <a:rPr lang="en-GB" smtClean="0"/>
              <a:t>08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70C4E-BEFB-4645-A30F-FA77502E9D68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067775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2243638"/>
            <a:ext cx="7762102" cy="3743557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6022610"/>
            <a:ext cx="7762102" cy="1968648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AF5CE-87E6-4BB0-8F04-D2AD62744F46}" type="datetimeFigureOut">
              <a:rPr lang="en-GB" smtClean="0"/>
              <a:t>08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70C4E-BEFB-4645-A30F-FA77502E9D68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30257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2395710"/>
            <a:ext cx="3824804" cy="57101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2395710"/>
            <a:ext cx="3824804" cy="57101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AF5CE-87E6-4BB0-8F04-D2AD62744F46}" type="datetimeFigureOut">
              <a:rPr lang="en-GB" smtClean="0"/>
              <a:t>08/0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70C4E-BEFB-4645-A30F-FA77502E9D68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930208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479144"/>
            <a:ext cx="7762102" cy="173949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2206137"/>
            <a:ext cx="3807226" cy="1081194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3287331"/>
            <a:ext cx="3807226" cy="48351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2206137"/>
            <a:ext cx="3825976" cy="1081194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3287331"/>
            <a:ext cx="3825976" cy="48351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AF5CE-87E6-4BB0-8F04-D2AD62744F46}" type="datetimeFigureOut">
              <a:rPr lang="en-GB" smtClean="0"/>
              <a:t>08/01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70C4E-BEFB-4645-A30F-FA77502E9D68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149010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AF5CE-87E6-4BB0-8F04-D2AD62744F46}" type="datetimeFigureOut">
              <a:rPr lang="en-GB" smtClean="0"/>
              <a:t>08/01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70C4E-BEFB-4645-A30F-FA77502E9D68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172422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AF5CE-87E6-4BB0-8F04-D2AD62744F46}" type="datetimeFigureOut">
              <a:rPr lang="en-GB" smtClean="0"/>
              <a:t>08/01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70C4E-BEFB-4645-A30F-FA77502E9D68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1922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599969"/>
            <a:ext cx="2902585" cy="2099892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295769"/>
            <a:ext cx="4556016" cy="6395505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699862"/>
            <a:ext cx="2902585" cy="5001827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AF5CE-87E6-4BB0-8F04-D2AD62744F46}" type="datetimeFigureOut">
              <a:rPr lang="en-GB" smtClean="0"/>
              <a:t>08/0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70C4E-BEFB-4645-A30F-FA77502E9D68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08946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599969"/>
            <a:ext cx="2902585" cy="2099892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295769"/>
            <a:ext cx="4556016" cy="6395505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699862"/>
            <a:ext cx="2902585" cy="5001827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AF5CE-87E6-4BB0-8F04-D2AD62744F46}" type="datetimeFigureOut">
              <a:rPr lang="en-GB" smtClean="0"/>
              <a:t>08/0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70C4E-BEFB-4645-A30F-FA77502E9D68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21351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479144"/>
            <a:ext cx="7762102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2395710"/>
            <a:ext cx="7762102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8341240"/>
            <a:ext cx="2024896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6AF5CE-87E6-4BB0-8F04-D2AD62744F46}" type="datetimeFigureOut">
              <a:rPr lang="en-GB" smtClean="0"/>
              <a:t>08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8341240"/>
            <a:ext cx="3037344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8341240"/>
            <a:ext cx="2024896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070C4E-BEFB-4645-A30F-FA77502E9D68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58133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>
            <a:extLst>
              <a:ext uri="{FF2B5EF4-FFF2-40B4-BE49-F238E27FC236}">
                <a16:creationId xmlns:a16="http://schemas.microsoft.com/office/drawing/2014/main" id="{6E835916-E82C-55A2-D100-7BB419C48685}"/>
              </a:ext>
            </a:extLst>
          </p:cNvPr>
          <p:cNvGrpSpPr>
            <a:grpSpLocks noChangeAspect="1"/>
          </p:cNvGrpSpPr>
          <p:nvPr/>
        </p:nvGrpSpPr>
        <p:grpSpPr>
          <a:xfrm>
            <a:off x="1484128" y="1175838"/>
            <a:ext cx="6039977" cy="2746361"/>
            <a:chOff x="983432" y="692698"/>
            <a:chExt cx="9335336" cy="4244752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3BA53EEA-CEE0-5098-01E2-E7E9E3C7409A}"/>
                </a:ext>
              </a:extLst>
            </p:cNvPr>
            <p:cNvGrpSpPr/>
            <p:nvPr/>
          </p:nvGrpSpPr>
          <p:grpSpPr>
            <a:xfrm>
              <a:off x="983432" y="692698"/>
              <a:ext cx="8346193" cy="2697499"/>
              <a:chOff x="1871068" y="3760053"/>
              <a:chExt cx="7573383" cy="2810841"/>
            </a:xfrm>
          </p:grpSpPr>
          <p:sp>
            <p:nvSpPr>
              <p:cNvPr id="6" name="Round Diagonal Corner Rectangle 14">
                <a:extLst>
                  <a:ext uri="{FF2B5EF4-FFF2-40B4-BE49-F238E27FC236}">
                    <a16:creationId xmlns:a16="http://schemas.microsoft.com/office/drawing/2014/main" id="{D303D6FE-A4D4-F45D-2856-F568BB326566}"/>
                  </a:ext>
                </a:extLst>
              </p:cNvPr>
              <p:cNvSpPr/>
              <p:nvPr/>
            </p:nvSpPr>
            <p:spPr>
              <a:xfrm>
                <a:off x="1871068" y="3761006"/>
                <a:ext cx="296197" cy="1741625"/>
              </a:xfrm>
              <a:prstGeom prst="round2DiagRect">
                <a:avLst/>
              </a:pr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vert="vert270" rtlCol="0" anchor="ctr"/>
              <a:lstStyle/>
              <a:p>
                <a:pPr algn="ctr"/>
                <a:r>
                  <a:rPr lang="en-US" sz="800" dirty="0">
                    <a:solidFill>
                      <a:schemeClr val="tx1"/>
                    </a:solidFill>
                  </a:rPr>
                  <a:t>Screening</a:t>
                </a:r>
              </a:p>
            </p:txBody>
          </p:sp>
          <p:sp>
            <p:nvSpPr>
              <p:cNvPr id="8" name="Round Diagonal Corner Rectangle 20">
                <a:extLst>
                  <a:ext uri="{FF2B5EF4-FFF2-40B4-BE49-F238E27FC236}">
                    <a16:creationId xmlns:a16="http://schemas.microsoft.com/office/drawing/2014/main" id="{0659D5E1-EC2B-29D2-D011-FF796F8E79AF}"/>
                  </a:ext>
                </a:extLst>
              </p:cNvPr>
              <p:cNvSpPr/>
              <p:nvPr/>
            </p:nvSpPr>
            <p:spPr>
              <a:xfrm>
                <a:off x="3493675" y="3761006"/>
                <a:ext cx="345876" cy="1741626"/>
              </a:xfrm>
              <a:prstGeom prst="round2DiagRect">
                <a:avLst/>
              </a:pr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vert="vert270" rtlCol="0" anchor="ctr"/>
              <a:lstStyle/>
              <a:p>
                <a:pPr algn="ctr"/>
                <a:r>
                  <a:rPr lang="en-US" sz="800" dirty="0">
                    <a:solidFill>
                      <a:schemeClr val="tx1"/>
                    </a:solidFill>
                  </a:rPr>
                  <a:t>Enrollment/Baseline (C1D1)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CF855FF8-F4F4-BCCF-57A0-87ECAEFDCD09}"/>
                  </a:ext>
                </a:extLst>
              </p:cNvPr>
              <p:cNvSpPr txBox="1"/>
              <p:nvPr/>
            </p:nvSpPr>
            <p:spPr>
              <a:xfrm>
                <a:off x="3902328" y="3978087"/>
                <a:ext cx="2422685" cy="5452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u="sng" dirty="0"/>
                  <a:t>Clinical and radiological</a:t>
                </a:r>
                <a:r>
                  <a:rPr lang="en-US" sz="800" u="sng" baseline="30000" dirty="0"/>
                  <a:t>†</a:t>
                </a:r>
                <a:r>
                  <a:rPr lang="en-US" sz="800" u="sng" dirty="0"/>
                  <a:t> evaluations</a:t>
                </a:r>
              </a:p>
              <a:p>
                <a:pPr algn="ctr"/>
                <a:r>
                  <a:rPr lang="en-US" sz="800"/>
                  <a:t>C1D1 </a:t>
                </a:r>
                <a:r>
                  <a:rPr lang="en-US" sz="800" dirty="0"/>
                  <a:t>&amp; D15; C2-26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17DC69C5-8D61-2AAF-D6CB-614D8BE8E550}"/>
                  </a:ext>
                </a:extLst>
              </p:cNvPr>
              <p:cNvSpPr txBox="1"/>
              <p:nvPr/>
            </p:nvSpPr>
            <p:spPr>
              <a:xfrm>
                <a:off x="4171954" y="4873726"/>
                <a:ext cx="2141956" cy="9170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150"/>
                  </a:spcAft>
                </a:pPr>
                <a:r>
                  <a:rPr lang="en-US" sz="800" u="sng" dirty="0"/>
                  <a:t>Study Drug Administration </a:t>
                </a:r>
              </a:p>
              <a:p>
                <a:pPr algn="ctr"/>
                <a:r>
                  <a:rPr lang="en-US" sz="800" dirty="0"/>
                  <a:t>C1D1-C26D21:</a:t>
                </a:r>
              </a:p>
              <a:p>
                <a:pPr algn="ctr"/>
                <a:r>
                  <a:rPr lang="en-US" sz="800" dirty="0" err="1"/>
                  <a:t>Tovorafenib</a:t>
                </a:r>
                <a:r>
                  <a:rPr lang="en-US" sz="800" dirty="0"/>
                  <a:t>*</a:t>
                </a:r>
              </a:p>
              <a:p>
                <a:pPr algn="ctr"/>
                <a:endParaRPr lang="en-US" sz="800" baseline="30000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CFFD2BCC-6934-61AA-4AB8-549150FA17B1}"/>
                  </a:ext>
                </a:extLst>
              </p:cNvPr>
              <p:cNvSpPr txBox="1"/>
              <p:nvPr/>
            </p:nvSpPr>
            <p:spPr>
              <a:xfrm>
                <a:off x="2091626" y="6025641"/>
                <a:ext cx="1334171" cy="5452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Eligibility evaluation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E4FF052E-442D-F4C4-C55E-344F58FCCAE6}"/>
                  </a:ext>
                </a:extLst>
              </p:cNvPr>
              <p:cNvSpPr txBox="1"/>
              <p:nvPr/>
            </p:nvSpPr>
            <p:spPr>
              <a:xfrm>
                <a:off x="4092941" y="6015217"/>
                <a:ext cx="4715702" cy="3469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/>
                  <a:t>Treatment phase</a:t>
                </a:r>
                <a:endParaRPr lang="en-US" sz="800" baseline="30000" dirty="0"/>
              </a:p>
            </p:txBody>
          </p:sp>
          <p:sp>
            <p:nvSpPr>
              <p:cNvPr id="13" name="Round Diagonal Corner Rectangle 26">
                <a:extLst>
                  <a:ext uri="{FF2B5EF4-FFF2-40B4-BE49-F238E27FC236}">
                    <a16:creationId xmlns:a16="http://schemas.microsoft.com/office/drawing/2014/main" id="{1EBE49FC-7642-9BEE-1A5C-24992FDD4851}"/>
                  </a:ext>
                </a:extLst>
              </p:cNvPr>
              <p:cNvSpPr/>
              <p:nvPr/>
            </p:nvSpPr>
            <p:spPr>
              <a:xfrm>
                <a:off x="6546900" y="3768217"/>
                <a:ext cx="292608" cy="1742579"/>
              </a:xfrm>
              <a:prstGeom prst="round2DiagRect">
                <a:avLst/>
              </a:pr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vert="vert270" rtlCol="0" anchor="ctr"/>
              <a:lstStyle/>
              <a:p>
                <a:pPr algn="ctr"/>
                <a:r>
                  <a:rPr lang="en-US" sz="800" dirty="0">
                    <a:solidFill>
                      <a:schemeClr val="tx1"/>
                    </a:solidFill>
                  </a:rPr>
                  <a:t>C27D1</a:t>
                </a:r>
              </a:p>
            </p:txBody>
          </p:sp>
          <p:sp>
            <p:nvSpPr>
              <p:cNvPr id="15" name="Round Diagonal Corner Rectangle 28">
                <a:extLst>
                  <a:ext uri="{FF2B5EF4-FFF2-40B4-BE49-F238E27FC236}">
                    <a16:creationId xmlns:a16="http://schemas.microsoft.com/office/drawing/2014/main" id="{E72316A1-9E08-C0CC-147C-E40DB5D46BC9}"/>
                  </a:ext>
                </a:extLst>
              </p:cNvPr>
              <p:cNvSpPr/>
              <p:nvPr/>
            </p:nvSpPr>
            <p:spPr>
              <a:xfrm>
                <a:off x="9151843" y="3760053"/>
                <a:ext cx="292608" cy="1742579"/>
              </a:xfrm>
              <a:prstGeom prst="round2DiagRect">
                <a:avLst/>
              </a:pr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vert="vert270" rtlCol="0" anchor="ctr"/>
              <a:lstStyle/>
              <a:p>
                <a:pPr algn="ctr"/>
                <a:r>
                  <a:rPr lang="en-US" sz="800" dirty="0">
                    <a:solidFill>
                      <a:schemeClr val="tx1"/>
                    </a:solidFill>
                  </a:rPr>
                  <a:t>End of study</a:t>
                </a:r>
              </a:p>
            </p:txBody>
          </p:sp>
          <p:sp>
            <p:nvSpPr>
              <p:cNvPr id="16" name="Right Brace 15">
                <a:extLst>
                  <a:ext uri="{FF2B5EF4-FFF2-40B4-BE49-F238E27FC236}">
                    <a16:creationId xmlns:a16="http://schemas.microsoft.com/office/drawing/2014/main" id="{E23D11B0-F0A5-0B27-143B-4D25B301C16E}"/>
                  </a:ext>
                </a:extLst>
              </p:cNvPr>
              <p:cNvSpPr/>
              <p:nvPr/>
            </p:nvSpPr>
            <p:spPr>
              <a:xfrm rot="5400000">
                <a:off x="2543862" y="5008521"/>
                <a:ext cx="363991" cy="1500548"/>
              </a:xfrm>
              <a:prstGeom prst="rightBrace">
                <a:avLst>
                  <a:gd name="adj1" fmla="val 36562"/>
                  <a:gd name="adj2" fmla="val 50000"/>
                </a:avLst>
              </a:prstGeom>
              <a:ln w="25400">
                <a:solidFill>
                  <a:schemeClr val="accent5">
                    <a:lumMod val="50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600" dirty="0"/>
              </a:p>
            </p:txBody>
          </p:sp>
          <p:sp>
            <p:nvSpPr>
              <p:cNvPr id="17" name="Right Brace 16">
                <a:extLst>
                  <a:ext uri="{FF2B5EF4-FFF2-40B4-BE49-F238E27FC236}">
                    <a16:creationId xmlns:a16="http://schemas.microsoft.com/office/drawing/2014/main" id="{C9F7DB7A-9988-4037-2405-1A82C6B11D7A}"/>
                  </a:ext>
                </a:extLst>
              </p:cNvPr>
              <p:cNvSpPr/>
              <p:nvPr/>
            </p:nvSpPr>
            <p:spPr>
              <a:xfrm rot="5400000">
                <a:off x="6274866" y="2855667"/>
                <a:ext cx="363990" cy="5806260"/>
              </a:xfrm>
              <a:prstGeom prst="rightBrace">
                <a:avLst>
                  <a:gd name="adj1" fmla="val 36562"/>
                  <a:gd name="adj2" fmla="val 50000"/>
                </a:avLst>
              </a:prstGeom>
              <a:ln w="25400">
                <a:solidFill>
                  <a:schemeClr val="accent5">
                    <a:lumMod val="50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600" dirty="0"/>
              </a:p>
            </p:txBody>
          </p: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D77C45F-21B4-4A8C-4E70-3C25AA3311FE}"/>
                </a:ext>
              </a:extLst>
            </p:cNvPr>
            <p:cNvSpPr txBox="1"/>
            <p:nvPr/>
          </p:nvSpPr>
          <p:spPr>
            <a:xfrm>
              <a:off x="983434" y="3653068"/>
              <a:ext cx="9335334" cy="1284382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800" dirty="0"/>
                <a:t>* 420mg/m</a:t>
              </a:r>
              <a:r>
                <a:rPr lang="en-US" sz="800" baseline="30000" dirty="0"/>
                <a:t>2 </a:t>
              </a:r>
              <a:r>
                <a:rPr lang="en-US" sz="800" dirty="0"/>
                <a:t>QW (not to exceed 600 mg);</a:t>
              </a:r>
              <a:r>
                <a:rPr lang="en-GB" sz="800" dirty="0"/>
                <a:t> cycle lengths are unique to each study treatment and are independent from study assessment schedules. All pre-dose assessments will be performed prior to </a:t>
              </a:r>
              <a:r>
                <a:rPr lang="en-GB" sz="800" dirty="0" err="1"/>
                <a:t>tovorafenib</a:t>
              </a:r>
              <a:r>
                <a:rPr lang="en-GB" sz="800" dirty="0"/>
                <a:t> administration.</a:t>
              </a:r>
              <a:r>
                <a:rPr lang="en-US" sz="800" dirty="0"/>
                <a:t> </a:t>
              </a:r>
              <a:r>
                <a:rPr lang="en-US" sz="800" baseline="30000" dirty="0"/>
                <a:t>†</a:t>
              </a:r>
              <a:r>
                <a:rPr lang="en-GB" sz="800" dirty="0"/>
                <a:t>Radiographic response assessment (MRI of brain/spine; performed as appropriate) will be performed at screening (pre-first dose) (≤28 days) and then every 12 weeks during the treatment phase.</a:t>
              </a:r>
              <a:endParaRPr lang="en-US" sz="800" dirty="0"/>
            </a:p>
            <a:p>
              <a:endParaRPr lang="en-US" sz="800" b="1" dirty="0"/>
            </a:p>
            <a:p>
              <a:r>
                <a:rPr lang="en-US" sz="800" b="1" dirty="0"/>
                <a:t>Abbreviations</a:t>
              </a:r>
              <a:r>
                <a:rPr lang="en-US" sz="800" dirty="0"/>
                <a:t>: C, cycle; D, day; EOS, end of study; MRI, magnetic resonance imaging; QW, once weekly.</a:t>
              </a:r>
              <a:endParaRPr lang="en-US" sz="800" dirty="0">
                <a:cs typeface="Calibri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5BAA248-F73B-DF54-2CD6-C6E669DE16AF}"/>
                </a:ext>
              </a:extLst>
            </p:cNvPr>
            <p:cNvSpPr txBox="1"/>
            <p:nvPr/>
          </p:nvSpPr>
          <p:spPr>
            <a:xfrm>
              <a:off x="6378427" y="901938"/>
              <a:ext cx="2669902" cy="5232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u="sng" dirty="0"/>
                <a:t>Clinical and radiological evaluations</a:t>
              </a:r>
            </a:p>
            <a:p>
              <a:pPr algn="ctr"/>
              <a:r>
                <a:rPr lang="en-US" sz="800" dirty="0"/>
                <a:t>C27D1 &amp; D1 of every 3</a:t>
              </a:r>
              <a:r>
                <a:rPr lang="en-US" sz="800" baseline="30000" dirty="0"/>
                <a:t>rd</a:t>
              </a:r>
              <a:r>
                <a:rPr lang="en-US" sz="800" dirty="0"/>
                <a:t> C-EOS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27EFFEF-355B-58F5-91D9-706BCB73B2C0}"/>
                </a:ext>
              </a:extLst>
            </p:cNvPr>
            <p:cNvSpPr txBox="1"/>
            <p:nvPr/>
          </p:nvSpPr>
          <p:spPr>
            <a:xfrm>
              <a:off x="6543785" y="1763291"/>
              <a:ext cx="2360527" cy="753187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>
                <a:spcAft>
                  <a:spcPts val="150"/>
                </a:spcAft>
              </a:pPr>
              <a:r>
                <a:rPr lang="en-US" sz="800" u="sng" dirty="0"/>
                <a:t>Study Drug Administration </a:t>
              </a:r>
            </a:p>
            <a:p>
              <a:pPr algn="ctr"/>
              <a:r>
                <a:rPr lang="en-US" sz="800" dirty="0"/>
                <a:t>C27D1-EOS:</a:t>
              </a:r>
            </a:p>
            <a:p>
              <a:pPr algn="ctr"/>
              <a:r>
                <a:rPr lang="en-US" sz="800" dirty="0"/>
                <a:t>continue on </a:t>
              </a:r>
              <a:r>
                <a:rPr lang="en-US" sz="800" dirty="0" err="1"/>
                <a:t>tovorafenib</a:t>
              </a:r>
              <a:r>
                <a:rPr lang="en-US" sz="800" dirty="0"/>
                <a:t>*</a:t>
              </a:r>
            </a:p>
          </p:txBody>
        </p: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E8BB4790-76F7-74AC-66C5-671071B758FA}"/>
                </a:ext>
              </a:extLst>
            </p:cNvPr>
            <p:cNvCxnSpPr>
              <a:cxnSpLocks/>
            </p:cNvCxnSpPr>
            <p:nvPr/>
          </p:nvCxnSpPr>
          <p:spPr>
            <a:xfrm>
              <a:off x="1317317" y="1556792"/>
              <a:ext cx="1386000" cy="0"/>
            </a:xfrm>
            <a:prstGeom prst="straightConnector1">
              <a:avLst/>
            </a:prstGeom>
            <a:ln w="50800">
              <a:solidFill>
                <a:schemeClr val="accent5">
                  <a:lumMod val="50000"/>
                </a:schemeClr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9C4E7D33-5076-BF02-7BBC-1793B6D9AC94}"/>
                </a:ext>
              </a:extLst>
            </p:cNvPr>
            <p:cNvSpPr/>
            <p:nvPr/>
          </p:nvSpPr>
          <p:spPr>
            <a:xfrm>
              <a:off x="1583424" y="1488279"/>
              <a:ext cx="868004" cy="1543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600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BC26D85-D9CA-0C6C-482D-50D878A09891}"/>
                </a:ext>
              </a:extLst>
            </p:cNvPr>
            <p:cNvSpPr txBox="1"/>
            <p:nvPr/>
          </p:nvSpPr>
          <p:spPr>
            <a:xfrm>
              <a:off x="1453544" y="1408944"/>
              <a:ext cx="1113546" cy="3329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/>
                <a:t>Day −28 to 0</a:t>
              </a:r>
            </a:p>
          </p:txBody>
        </p: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0C5F6148-2CA6-5F69-AAAA-C5946CBFB5B2}"/>
                </a:ext>
              </a:extLst>
            </p:cNvPr>
            <p:cNvCxnSpPr>
              <a:cxnSpLocks/>
            </p:cNvCxnSpPr>
            <p:nvPr/>
          </p:nvCxnSpPr>
          <p:spPr>
            <a:xfrm>
              <a:off x="6528048" y="1556792"/>
              <a:ext cx="2412000" cy="0"/>
            </a:xfrm>
            <a:prstGeom prst="straightConnector1">
              <a:avLst/>
            </a:prstGeom>
            <a:ln w="50800">
              <a:solidFill>
                <a:schemeClr val="accent5">
                  <a:lumMod val="50000"/>
                </a:schemeClr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D35AA002-AF67-BF17-F649-DE440C428D20}"/>
                </a:ext>
              </a:extLst>
            </p:cNvPr>
            <p:cNvCxnSpPr>
              <a:cxnSpLocks/>
            </p:cNvCxnSpPr>
            <p:nvPr/>
          </p:nvCxnSpPr>
          <p:spPr>
            <a:xfrm>
              <a:off x="3209652" y="1556792"/>
              <a:ext cx="2893347" cy="0"/>
            </a:xfrm>
            <a:prstGeom prst="straightConnector1">
              <a:avLst/>
            </a:prstGeom>
            <a:ln w="50800">
              <a:solidFill>
                <a:schemeClr val="accent5">
                  <a:lumMod val="50000"/>
                </a:schemeClr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AE2AA19D-8B26-4AAD-6809-FFD30163E582}"/>
              </a:ext>
            </a:extLst>
          </p:cNvPr>
          <p:cNvGrpSpPr/>
          <p:nvPr/>
        </p:nvGrpSpPr>
        <p:grpSpPr>
          <a:xfrm>
            <a:off x="1482701" y="5336460"/>
            <a:ext cx="5402861" cy="3134589"/>
            <a:chOff x="2771577" y="3082264"/>
            <a:chExt cx="5402861" cy="3134589"/>
          </a:xfrm>
        </p:grpSpPr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D2E611D2-DE1E-CAFE-18F3-B73ED6350D53}"/>
                </a:ext>
              </a:extLst>
            </p:cNvPr>
            <p:cNvGrpSpPr/>
            <p:nvPr/>
          </p:nvGrpSpPr>
          <p:grpSpPr>
            <a:xfrm>
              <a:off x="2774438" y="3088306"/>
              <a:ext cx="5400000" cy="3128547"/>
              <a:chOff x="864286" y="2839317"/>
              <a:chExt cx="5400000" cy="3128547"/>
            </a:xfrm>
          </p:grpSpPr>
          <p:grpSp>
            <p:nvGrpSpPr>
              <p:cNvPr id="48" name="Group 47">
                <a:extLst>
                  <a:ext uri="{FF2B5EF4-FFF2-40B4-BE49-F238E27FC236}">
                    <a16:creationId xmlns:a16="http://schemas.microsoft.com/office/drawing/2014/main" id="{32983C8B-662C-FEFD-1E37-2B1330B3C253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864286" y="2839317"/>
                <a:ext cx="5400000" cy="3128547"/>
                <a:chOff x="983434" y="692698"/>
                <a:chExt cx="8346193" cy="4835458"/>
              </a:xfrm>
            </p:grpSpPr>
            <p:grpSp>
              <p:nvGrpSpPr>
                <p:cNvPr id="49" name="Group 48">
                  <a:extLst>
                    <a:ext uri="{FF2B5EF4-FFF2-40B4-BE49-F238E27FC236}">
                      <a16:creationId xmlns:a16="http://schemas.microsoft.com/office/drawing/2014/main" id="{109FC41B-3952-A1D7-0EDE-8BB73C2A2945}"/>
                    </a:ext>
                  </a:extLst>
                </p:cNvPr>
                <p:cNvGrpSpPr/>
                <p:nvPr/>
              </p:nvGrpSpPr>
              <p:grpSpPr>
                <a:xfrm>
                  <a:off x="1098613" y="692698"/>
                  <a:ext cx="8231012" cy="2697499"/>
                  <a:chOff x="1975584" y="3760053"/>
                  <a:chExt cx="7468867" cy="2810841"/>
                </a:xfrm>
              </p:grpSpPr>
              <p:sp>
                <p:nvSpPr>
                  <p:cNvPr id="59" name="Round Diagonal Corner Rectangle 20">
                    <a:extLst>
                      <a:ext uri="{FF2B5EF4-FFF2-40B4-BE49-F238E27FC236}">
                        <a16:creationId xmlns:a16="http://schemas.microsoft.com/office/drawing/2014/main" id="{C28794F0-FED9-4BBC-F9B2-1DA1E5488E33}"/>
                      </a:ext>
                    </a:extLst>
                  </p:cNvPr>
                  <p:cNvSpPr/>
                  <p:nvPr/>
                </p:nvSpPr>
                <p:spPr>
                  <a:xfrm>
                    <a:off x="3493675" y="3761006"/>
                    <a:ext cx="389195" cy="1741625"/>
                  </a:xfrm>
                  <a:prstGeom prst="round2Diag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r>
                      <a:rPr lang="en-US" sz="800" dirty="0">
                        <a:solidFill>
                          <a:schemeClr val="tx1"/>
                        </a:solidFill>
                      </a:rPr>
                      <a:t>Enrollment/Baseline (C1D1)</a:t>
                    </a:r>
                  </a:p>
                </p:txBody>
              </p:sp>
              <p:sp>
                <p:nvSpPr>
                  <p:cNvPr id="60" name="TextBox 59">
                    <a:extLst>
                      <a:ext uri="{FF2B5EF4-FFF2-40B4-BE49-F238E27FC236}">
                        <a16:creationId xmlns:a16="http://schemas.microsoft.com/office/drawing/2014/main" id="{B3AF24C3-C771-768B-6A0F-2A5380AD6E4D}"/>
                      </a:ext>
                    </a:extLst>
                  </p:cNvPr>
                  <p:cNvSpPr txBox="1"/>
                  <p:nvPr/>
                </p:nvSpPr>
                <p:spPr>
                  <a:xfrm>
                    <a:off x="5213292" y="3978087"/>
                    <a:ext cx="2422685" cy="54525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u="sng" dirty="0"/>
                      <a:t>Clinical and radiological</a:t>
                    </a:r>
                    <a:r>
                      <a:rPr lang="en-US" sz="800" u="sng" baseline="30000" dirty="0"/>
                      <a:t> †</a:t>
                    </a:r>
                    <a:r>
                      <a:rPr lang="en-US" sz="800" u="sng" dirty="0"/>
                      <a:t> evaluations</a:t>
                    </a:r>
                  </a:p>
                  <a:p>
                    <a:pPr algn="ctr"/>
                    <a:r>
                      <a:rPr lang="en-US" sz="800" dirty="0"/>
                      <a:t>C1D1 &amp; D15; C2-EOS</a:t>
                    </a:r>
                  </a:p>
                </p:txBody>
              </p:sp>
              <p:sp>
                <p:nvSpPr>
                  <p:cNvPr id="61" name="TextBox 60">
                    <a:extLst>
                      <a:ext uri="{FF2B5EF4-FFF2-40B4-BE49-F238E27FC236}">
                        <a16:creationId xmlns:a16="http://schemas.microsoft.com/office/drawing/2014/main" id="{06A61422-295E-9319-64A8-1AA65554E999}"/>
                      </a:ext>
                    </a:extLst>
                  </p:cNvPr>
                  <p:cNvSpPr txBox="1"/>
                  <p:nvPr/>
                </p:nvSpPr>
                <p:spPr>
                  <a:xfrm>
                    <a:off x="5390370" y="4873726"/>
                    <a:ext cx="2141956" cy="7848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>
                      <a:spcAft>
                        <a:spcPts val="150"/>
                      </a:spcAft>
                    </a:pPr>
                    <a:r>
                      <a:rPr lang="en-US" sz="800" u="sng" dirty="0"/>
                      <a:t>Study Drug Administration </a:t>
                    </a:r>
                  </a:p>
                  <a:p>
                    <a:pPr algn="ctr"/>
                    <a:r>
                      <a:rPr lang="en-US" sz="800"/>
                      <a:t>C1D1-EOS</a:t>
                    </a:r>
                    <a:r>
                      <a:rPr lang="en-US" sz="800" dirty="0"/>
                      <a:t>:</a:t>
                    </a:r>
                  </a:p>
                  <a:p>
                    <a:pPr algn="ctr"/>
                    <a:r>
                      <a:rPr lang="en-US" sz="800" dirty="0"/>
                      <a:t>SoC chemotherapy</a:t>
                    </a:r>
                    <a:r>
                      <a:rPr lang="en-GB" sz="800" dirty="0">
                        <a:solidFill>
                          <a:srgbClr val="202124"/>
                        </a:solidFill>
                        <a:latin typeface="Google Sans"/>
                      </a:rPr>
                      <a:t>*</a:t>
                    </a:r>
                    <a:endParaRPr lang="en-US" sz="800" baseline="30000" dirty="0"/>
                  </a:p>
                </p:txBody>
              </p:sp>
              <p:sp>
                <p:nvSpPr>
                  <p:cNvPr id="62" name="TextBox 61">
                    <a:extLst>
                      <a:ext uri="{FF2B5EF4-FFF2-40B4-BE49-F238E27FC236}">
                        <a16:creationId xmlns:a16="http://schemas.microsoft.com/office/drawing/2014/main" id="{A3D84C0A-5ECF-3C26-E962-6C6E93083E7B}"/>
                      </a:ext>
                    </a:extLst>
                  </p:cNvPr>
                  <p:cNvSpPr txBox="1"/>
                  <p:nvPr/>
                </p:nvSpPr>
                <p:spPr>
                  <a:xfrm>
                    <a:off x="2091626" y="6025641"/>
                    <a:ext cx="1334171" cy="54525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Eligibility evaluation</a:t>
                    </a:r>
                  </a:p>
                </p:txBody>
              </p:sp>
              <p:sp>
                <p:nvSpPr>
                  <p:cNvPr id="63" name="TextBox 62">
                    <a:extLst>
                      <a:ext uri="{FF2B5EF4-FFF2-40B4-BE49-F238E27FC236}">
                        <a16:creationId xmlns:a16="http://schemas.microsoft.com/office/drawing/2014/main" id="{BE85667F-6AA4-E2C7-8C2E-012559362F7F}"/>
                      </a:ext>
                    </a:extLst>
                  </p:cNvPr>
                  <p:cNvSpPr txBox="1"/>
                  <p:nvPr/>
                </p:nvSpPr>
                <p:spPr>
                  <a:xfrm>
                    <a:off x="4092941" y="6015216"/>
                    <a:ext cx="4715702" cy="3469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/>
                      <a:t>Treatment phase</a:t>
                    </a:r>
                    <a:endParaRPr lang="en-US" sz="800" baseline="30000" dirty="0"/>
                  </a:p>
                </p:txBody>
              </p:sp>
              <p:sp>
                <p:nvSpPr>
                  <p:cNvPr id="65" name="Round Diagonal Corner Rectangle 28">
                    <a:extLst>
                      <a:ext uri="{FF2B5EF4-FFF2-40B4-BE49-F238E27FC236}">
                        <a16:creationId xmlns:a16="http://schemas.microsoft.com/office/drawing/2014/main" id="{3062D3FC-ED1D-041A-D725-8B5D55AAA2FE}"/>
                      </a:ext>
                    </a:extLst>
                  </p:cNvPr>
                  <p:cNvSpPr/>
                  <p:nvPr/>
                </p:nvSpPr>
                <p:spPr>
                  <a:xfrm>
                    <a:off x="9151843" y="3760053"/>
                    <a:ext cx="292608" cy="1742579"/>
                  </a:xfrm>
                  <a:prstGeom prst="round2Diag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r>
                      <a:rPr lang="en-US" sz="800" dirty="0">
                        <a:solidFill>
                          <a:schemeClr val="tx1"/>
                        </a:solidFill>
                      </a:rPr>
                      <a:t>End of study</a:t>
                    </a:r>
                  </a:p>
                </p:txBody>
              </p:sp>
              <p:sp>
                <p:nvSpPr>
                  <p:cNvPr id="66" name="Right Brace 65">
                    <a:extLst>
                      <a:ext uri="{FF2B5EF4-FFF2-40B4-BE49-F238E27FC236}">
                        <a16:creationId xmlns:a16="http://schemas.microsoft.com/office/drawing/2014/main" id="{FEF64231-140C-C0A9-58CE-B2FDEF9D9460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2543862" y="5008521"/>
                    <a:ext cx="363991" cy="1500548"/>
                  </a:xfrm>
                  <a:prstGeom prst="rightBrace">
                    <a:avLst>
                      <a:gd name="adj1" fmla="val 36562"/>
                      <a:gd name="adj2" fmla="val 50000"/>
                    </a:avLst>
                  </a:prstGeom>
                  <a:ln w="25400">
                    <a:solidFill>
                      <a:schemeClr val="accent5">
                        <a:lumMod val="50000"/>
                      </a:schemeClr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600" dirty="0"/>
                  </a:p>
                </p:txBody>
              </p:sp>
              <p:sp>
                <p:nvSpPr>
                  <p:cNvPr id="67" name="Right Brace 66">
                    <a:extLst>
                      <a:ext uri="{FF2B5EF4-FFF2-40B4-BE49-F238E27FC236}">
                        <a16:creationId xmlns:a16="http://schemas.microsoft.com/office/drawing/2014/main" id="{E0171D58-FC06-1AF6-3CB8-9D8481594FD7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6274866" y="2855667"/>
                    <a:ext cx="363990" cy="5806260"/>
                  </a:xfrm>
                  <a:prstGeom prst="rightBrace">
                    <a:avLst>
                      <a:gd name="adj1" fmla="val 36562"/>
                      <a:gd name="adj2" fmla="val 50000"/>
                    </a:avLst>
                  </a:prstGeom>
                  <a:ln w="25400">
                    <a:solidFill>
                      <a:schemeClr val="accent5">
                        <a:lumMod val="50000"/>
                      </a:schemeClr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600" dirty="0"/>
                  </a:p>
                </p:txBody>
              </p:sp>
            </p:grp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F8F84EA4-81F1-D46E-5B99-F0C350A49A89}"/>
                    </a:ext>
                  </a:extLst>
                </p:cNvPr>
                <p:cNvSpPr txBox="1"/>
                <p:nvPr/>
              </p:nvSpPr>
              <p:spPr>
                <a:xfrm>
                  <a:off x="983434" y="3672937"/>
                  <a:ext cx="8346193" cy="1855219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 rtlCol="0" anchor="t">
                  <a:spAutoFit/>
                </a:bodyPr>
                <a:lstStyle/>
                <a:p>
                  <a:r>
                    <a:rPr lang="en-GB" sz="800" dirty="0"/>
                    <a:t>*SoC chemotherapy will be investigator’s choice of COG-V/C, </a:t>
                  </a:r>
                  <a:r>
                    <a:rPr lang="en-GB" sz="800" dirty="0" err="1"/>
                    <a:t>SIOPe</a:t>
                  </a:r>
                  <a:r>
                    <a:rPr lang="en-GB" sz="800" dirty="0"/>
                    <a:t>-V/C or vinblastine; cycle lengths are unique to each study treatment (COG–V/C, </a:t>
                  </a:r>
                  <a:r>
                    <a:rPr lang="en-GB" sz="800" dirty="0" err="1"/>
                    <a:t>SIOPe</a:t>
                  </a:r>
                  <a:r>
                    <a:rPr lang="en-GB" sz="800" dirty="0"/>
                    <a:t>-LGG-V/C, or VBL) and are independent from study assessment schedules. Treatment and assessments for Arm 2 patients should occur at each indicated timepoint (± 3 days). All pre-dose assessments will be performed prior to chemotherapy administration.</a:t>
                  </a:r>
                  <a:r>
                    <a:rPr lang="en-US" sz="800" baseline="30000" dirty="0"/>
                    <a:t>†</a:t>
                  </a:r>
                  <a:r>
                    <a:rPr lang="en-GB" sz="800" dirty="0"/>
                    <a:t>Radiographic response assessment (MRI of brain/spine; performed as appropriate) will be performed at screening (pre-first dose) (≤28 days), and then every 12 weeks during the treatment phase.</a:t>
                  </a:r>
                  <a:endParaRPr lang="en-US" sz="800" b="1" baseline="30000" dirty="0"/>
                </a:p>
                <a:p>
                  <a:endParaRPr lang="en-US" sz="800" b="1" dirty="0"/>
                </a:p>
                <a:p>
                  <a:r>
                    <a:rPr lang="en-US" sz="800" b="1" dirty="0"/>
                    <a:t>Abbreviations</a:t>
                  </a:r>
                  <a:r>
                    <a:rPr lang="en-US" sz="800" dirty="0"/>
                    <a:t>: C, cycle; COG-V/C, </a:t>
                  </a:r>
                  <a:r>
                    <a:rPr lang="en-US" sz="800" dirty="0">
                      <a:ea typeface="Calibri" panose="020F0502020204030204" pitchFamily="34" charset="0"/>
                    </a:rPr>
                    <a:t>Children’s Oncology Group-vincristine/carboplatin; </a:t>
                  </a:r>
                  <a:r>
                    <a:rPr lang="en-US" sz="800" dirty="0"/>
                    <a:t>D, day; EOS, end of study; MRI, magnetic resonance imaging; </a:t>
                  </a:r>
                  <a:r>
                    <a:rPr lang="en-US" sz="800" err="1">
                      <a:ea typeface="Calibri" panose="020F0502020204030204" pitchFamily="34" charset="0"/>
                    </a:rPr>
                    <a:t>SIOPe</a:t>
                  </a:r>
                  <a:r>
                    <a:rPr lang="en-US" sz="800" dirty="0">
                      <a:ea typeface="Calibri" panose="020F0502020204030204" pitchFamily="34" charset="0"/>
                    </a:rPr>
                    <a:t>-LGG-V/C: Society of </a:t>
                  </a:r>
                  <a:r>
                    <a:rPr lang="en-US" sz="800" err="1">
                      <a:ea typeface="Calibri" panose="020F0502020204030204" pitchFamily="34" charset="0"/>
                    </a:rPr>
                    <a:t>Paediatric</a:t>
                  </a:r>
                  <a:r>
                    <a:rPr lang="en-US" sz="800" dirty="0">
                      <a:ea typeface="Calibri" panose="020F0502020204030204" pitchFamily="34" charset="0"/>
                    </a:rPr>
                    <a:t> Oncology Europe-low-grade glioma vincristine/carboplatin.</a:t>
                  </a:r>
                  <a:endParaRPr lang="en-US" sz="800" dirty="0"/>
                </a:p>
              </p:txBody>
            </p:sp>
            <p:cxnSp>
              <p:nvCxnSpPr>
                <p:cNvPr id="53" name="Straight Arrow Connector 52">
                  <a:extLst>
                    <a:ext uri="{FF2B5EF4-FFF2-40B4-BE49-F238E27FC236}">
                      <a16:creationId xmlns:a16="http://schemas.microsoft.com/office/drawing/2014/main" id="{0F789C4E-31B2-6822-E576-FB7B97ACC72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17317" y="1556792"/>
                  <a:ext cx="1386000" cy="0"/>
                </a:xfrm>
                <a:prstGeom prst="straightConnector1">
                  <a:avLst/>
                </a:prstGeom>
                <a:ln w="50800">
                  <a:solidFill>
                    <a:schemeClr val="accent5">
                      <a:lumMod val="50000"/>
                    </a:schemeClr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4" name="Rectangle 53">
                  <a:extLst>
                    <a:ext uri="{FF2B5EF4-FFF2-40B4-BE49-F238E27FC236}">
                      <a16:creationId xmlns:a16="http://schemas.microsoft.com/office/drawing/2014/main" id="{9CE0D2F4-8F6C-743C-C706-D4BA09CAD884}"/>
                    </a:ext>
                  </a:extLst>
                </p:cNvPr>
                <p:cNvSpPr/>
                <p:nvPr/>
              </p:nvSpPr>
              <p:spPr>
                <a:xfrm>
                  <a:off x="1583428" y="1515370"/>
                  <a:ext cx="868004" cy="16305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600"/>
                </a:p>
              </p:txBody>
            </p: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FEAC3F51-2C97-DCA0-1290-BB75FE3C52BC}"/>
                    </a:ext>
                  </a:extLst>
                </p:cNvPr>
                <p:cNvSpPr txBox="1"/>
                <p:nvPr/>
              </p:nvSpPr>
              <p:spPr>
                <a:xfrm>
                  <a:off x="1443370" y="1399836"/>
                  <a:ext cx="1113546" cy="3329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/>
                    <a:t>Day −28 to 0</a:t>
                  </a:r>
                </a:p>
              </p:txBody>
            </p:sp>
          </p:grpSp>
          <p:cxnSp>
            <p:nvCxnSpPr>
              <p:cNvPr id="68" name="Straight Arrow Connector 67">
                <a:extLst>
                  <a:ext uri="{FF2B5EF4-FFF2-40B4-BE49-F238E27FC236}">
                    <a16:creationId xmlns:a16="http://schemas.microsoft.com/office/drawing/2014/main" id="{39A7CC94-19A1-2863-4F9D-F78E4C476E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87992" y="3398387"/>
                <a:ext cx="3636000" cy="0"/>
              </a:xfrm>
              <a:prstGeom prst="straightConnector1">
                <a:avLst/>
              </a:prstGeom>
              <a:ln w="50800">
                <a:solidFill>
                  <a:schemeClr val="accent5">
                    <a:lumMod val="50000"/>
                  </a:schemeClr>
                </a:solidFill>
                <a:headEnd type="non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" name="Round Diagonal Corner Rectangle 14">
              <a:extLst>
                <a:ext uri="{FF2B5EF4-FFF2-40B4-BE49-F238E27FC236}">
                  <a16:creationId xmlns:a16="http://schemas.microsoft.com/office/drawing/2014/main" id="{27E4148D-8395-4554-B070-8CCAE64C531F}"/>
                </a:ext>
              </a:extLst>
            </p:cNvPr>
            <p:cNvSpPr/>
            <p:nvPr/>
          </p:nvSpPr>
          <p:spPr>
            <a:xfrm>
              <a:off x="2771577" y="3082264"/>
              <a:ext cx="211195" cy="1081397"/>
            </a:xfrm>
            <a:prstGeom prst="round2Diag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</a:rPr>
                <a:t>Screening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E25D0849-613F-F5C2-5C48-70CE308D1707}"/>
              </a:ext>
            </a:extLst>
          </p:cNvPr>
          <p:cNvSpPr txBox="1"/>
          <p:nvPr/>
        </p:nvSpPr>
        <p:spPr>
          <a:xfrm>
            <a:off x="1482701" y="467321"/>
            <a:ext cx="22706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1F1ADF3-35BC-9C48-A26F-8C0F5FC04972}"/>
              </a:ext>
            </a:extLst>
          </p:cNvPr>
          <p:cNvSpPr txBox="1"/>
          <p:nvPr/>
        </p:nvSpPr>
        <p:spPr>
          <a:xfrm>
            <a:off x="1284089" y="4150762"/>
            <a:ext cx="6096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Figure 1. Treatment Schema for Arm 1 –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</a:rPr>
              <a:t>Tovorafenib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</a:rPr>
              <a:t> </a:t>
            </a:r>
            <a:endParaRPr lang="en-GB" sz="12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E33B0E5-2DC8-DA25-B101-9DC2DB059749}"/>
              </a:ext>
            </a:extLst>
          </p:cNvPr>
          <p:cNvSpPr txBox="1"/>
          <p:nvPr/>
        </p:nvSpPr>
        <p:spPr>
          <a:xfrm>
            <a:off x="1284089" y="8740385"/>
            <a:ext cx="6096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</a:rPr>
              <a:t>Figure 2. Treatment Schema for Arm 2 – SoC Chemotherapy</a:t>
            </a: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</a:rPr>
              <a:t> 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6688481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FD812570B7E3246928563CF90AEEF4B" ma:contentTypeVersion="14" ma:contentTypeDescription="Create a new document." ma:contentTypeScope="" ma:versionID="1e4a520c664e20415c2deb94f8b83c28">
  <xsd:schema xmlns:xsd="http://www.w3.org/2001/XMLSchema" xmlns:xs="http://www.w3.org/2001/XMLSchema" xmlns:p="http://schemas.microsoft.com/office/2006/metadata/properties" xmlns:ns2="37f2f237-a865-421f-86a3-5f2741ee6026" xmlns:ns3="76aac337-73dc-4b95-b89b-e96aac086adc" targetNamespace="http://schemas.microsoft.com/office/2006/metadata/properties" ma:root="true" ma:fieldsID="b01501b68b636f256937eedf0ad4faed" ns2:_="" ns3:_="">
    <xsd:import namespace="37f2f237-a865-421f-86a3-5f2741ee6026"/>
    <xsd:import namespace="76aac337-73dc-4b95-b89b-e96aac086ad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LengthInSeconds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7f2f237-a865-421f-86a3-5f2741ee602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5" nillable="true" ma:taxonomy="true" ma:internalName="lcf76f155ced4ddcb4097134ff3c332f" ma:taxonomyFieldName="MediaServiceImageTags" ma:displayName="Image Tags" ma:readOnly="false" ma:fieldId="{5cf76f15-5ced-4ddc-b409-7134ff3c332f}" ma:taxonomyMulti="true" ma:sspId="a1b2f1c0-b4c5-4a4f-9943-5c19555bea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7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21" nillable="true" ma:displayName="Location" ma:description="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6aac337-73dc-4b95-b89b-e96aac086ad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6" nillable="true" ma:displayName="Taxonomy Catch All Column" ma:hidden="true" ma:list="{63db9b75-9646-4d36-b795-128692ff56b7}" ma:internalName="TaxCatchAll" ma:showField="CatchAllData" ma:web="76aac337-73dc-4b95-b89b-e96aac086ad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76aac337-73dc-4b95-b89b-e96aac086adc" xsi:nil="true"/>
    <lcf76f155ced4ddcb4097134ff3c332f xmlns="37f2f237-a865-421f-86a3-5f2741ee6026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53D409A6-C86B-4252-A4E9-7F60A8CCEDA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7f2f237-a865-421f-86a3-5f2741ee6026"/>
    <ds:schemaRef ds:uri="76aac337-73dc-4b95-b89b-e96aac086ad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6447D375-0EDD-4FE2-AA71-DB354DBBAF2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2A01527-C925-4169-BDA4-82B0AB8A8F3A}">
  <ds:schemaRefs>
    <ds:schemaRef ds:uri="http://schemas.microsoft.com/office/2006/metadata/properties"/>
    <ds:schemaRef ds:uri="http://schemas.microsoft.com/office/infopath/2007/PartnerControls"/>
    <ds:schemaRef ds:uri="76aac337-73dc-4b95-b89b-e96aac086adc"/>
    <ds:schemaRef ds:uri="37f2f237-a865-421f-86a3-5f2741ee6026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82</TotalTime>
  <Words>384</Words>
  <Application>Microsoft Office PowerPoint</Application>
  <PresentationFormat>Custom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Google San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ncer Communications</dc:creator>
  <cp:lastModifiedBy>Molly Hoke</cp:lastModifiedBy>
  <cp:revision>17</cp:revision>
  <dcterms:created xsi:type="dcterms:W3CDTF">2023-06-15T13:20:32Z</dcterms:created>
  <dcterms:modified xsi:type="dcterms:W3CDTF">2024-01-09T00:37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FD812570B7E3246928563CF90AEEF4B</vt:lpwstr>
  </property>
  <property fmtid="{D5CDD505-2E9C-101B-9397-08002B2CF9AE}" pid="3" name="Order">
    <vt:r8>1578800</vt:r8>
  </property>
  <property fmtid="{D5CDD505-2E9C-101B-9397-08002B2CF9AE}" pid="4" name="MediaServiceImageTags">
    <vt:lpwstr/>
  </property>
</Properties>
</file>